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74"/>
  </p:normalViewPr>
  <p:slideViewPr>
    <p:cSldViewPr snapToGrid="0" snapToObjects="1">
      <p:cViewPr varScale="1">
        <p:scale>
          <a:sx n="131" d="100"/>
          <a:sy n="131" d="100"/>
        </p:scale>
        <p:origin x="37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19BE58-C184-8944-9FA7-58316871514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026DF3A-9E72-694A-85CB-13381209E90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DCFEC0-F0E8-6A46-B315-7D1A241BE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3C354B-1A4C-A442-B5E0-FBBE5AA99D86}" type="datetimeFigureOut">
              <a:rPr lang="en-US" smtClean="0"/>
              <a:t>3/30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021975-ED1A-C442-9069-ED50CDCAFC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3F3C92-293C-6743-AD7F-E1EA0094F5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50106-2007-B641-8F44-4FFD711B4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86376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6497E1-F540-584F-ACC6-6EB8E0E3B0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8444C4A-7EBC-744B-85EB-4932CAF9C3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D8B1D2-7C6C-5A49-A0B6-166FF71100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3C354B-1A4C-A442-B5E0-FBBE5AA99D86}" type="datetimeFigureOut">
              <a:rPr lang="en-US" smtClean="0"/>
              <a:t>3/30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2EA8F2-932D-1E49-A647-B4075876A2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88C0B0-F034-314D-AAB2-96A4CFA965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50106-2007-B641-8F44-4FFD711B4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12137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49F2C98-E37B-F94C-94FB-0D8A1696714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253CC71-4031-1544-B0AB-E705A43AB6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926340-2A26-C940-A8EF-F6983525C2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3C354B-1A4C-A442-B5E0-FBBE5AA99D86}" type="datetimeFigureOut">
              <a:rPr lang="en-US" smtClean="0"/>
              <a:t>3/30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19B500-2D43-344B-ABB6-02BBC391A5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07940C-C316-A741-9C76-710A602E2B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50106-2007-B641-8F44-4FFD711B4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3725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B21D7F-D95D-7B41-973A-45A96EC0CB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36A1EE-5F2D-D445-B805-CB43E6D5E17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B51C0C-F24B-2F41-A11C-C40B9FD6E8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3C354B-1A4C-A442-B5E0-FBBE5AA99D86}" type="datetimeFigureOut">
              <a:rPr lang="en-US" smtClean="0"/>
              <a:t>3/30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EEC241-05FF-4944-8194-358F0CAC41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6EEE2C-9584-7742-9518-2E022F117A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50106-2007-B641-8F44-4FFD711B4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34630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2F8C9A-E1CE-7E47-BCE7-C9B291B864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141B8F6-154D-7147-A3FF-05A795AEFD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84053C-4BB3-A043-9FA4-0F3ABAF3E8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3C354B-1A4C-A442-B5E0-FBBE5AA99D86}" type="datetimeFigureOut">
              <a:rPr lang="en-US" smtClean="0"/>
              <a:t>3/30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B98018-7878-724E-AE98-3B6373FC8E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B3DD72-C1E5-5F4F-8907-983328750B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50106-2007-B641-8F44-4FFD711B4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96330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AFA547-5CBB-024A-9D3C-4DDC7C886F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299E67-9934-474B-9D4F-FF161A9EB75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14B3AAA-CFB3-A44F-A91E-4DB80C045C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4BA71E-8A98-C344-BA82-5DE0EF4BF2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3C354B-1A4C-A442-B5E0-FBBE5AA99D86}" type="datetimeFigureOut">
              <a:rPr lang="en-US" smtClean="0"/>
              <a:t>3/30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FBDA6F1-1A0E-A544-BC8F-A7169E961D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4372076-AE1E-D64F-9CEC-7412DB3515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50106-2007-B641-8F44-4FFD711B4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87340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1F7986-69B6-7D4E-BDC6-86F36C9AF8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236727-D7F1-F74C-A8E3-0A31122061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3DBE7E7-B611-0347-BE4F-45BDD076F2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E76A0CC-0A32-1B40-BF88-85F12413074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157FB6F-9751-3649-B4CB-A5FEE789F02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1C8ED9D-58C1-3C4C-A053-EAB607EDB0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3C354B-1A4C-A442-B5E0-FBBE5AA99D86}" type="datetimeFigureOut">
              <a:rPr lang="en-US" smtClean="0"/>
              <a:t>3/30/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92F9AC1-C250-0C4E-BF96-38B6325A2A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C7F39CA-7C56-F149-88DB-FC8CD64B21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50106-2007-B641-8F44-4FFD711B4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33340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E58D93-6CDE-2646-9BCC-C784336B4A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934F209-1FE2-244A-A468-E4F2BC9DFD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3C354B-1A4C-A442-B5E0-FBBE5AA99D86}" type="datetimeFigureOut">
              <a:rPr lang="en-US" smtClean="0"/>
              <a:t>3/30/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FD3CBF0-5094-834B-A48C-05DBAA459E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08D488D-A888-0F41-820E-FBD1976361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50106-2007-B641-8F44-4FFD711B4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1301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B85DC71-A08E-2142-ADD8-4C91A5D8C3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3C354B-1A4C-A442-B5E0-FBBE5AA99D86}" type="datetimeFigureOut">
              <a:rPr lang="en-US" smtClean="0"/>
              <a:t>3/30/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A732576-42DF-FA44-8600-7E6CD74D75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B43A210-9D6A-1E43-ADBC-47126FC178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50106-2007-B641-8F44-4FFD711B4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59008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362DDC-2286-8B43-B182-9100B9F02C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5A49330-1C81-9647-8177-F32B1371B80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89AB218-5443-8846-BDF0-1A06FF886E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C1F3CC-DA0F-464A-8685-79205A58E7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3C354B-1A4C-A442-B5E0-FBBE5AA99D86}" type="datetimeFigureOut">
              <a:rPr lang="en-US" smtClean="0"/>
              <a:t>3/30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17DB1A-109A-3541-8BB0-16526A74C3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8B8067-CF5A-4A43-9F18-463C9B5F21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50106-2007-B641-8F44-4FFD711B4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54071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6C6A43-18A6-4044-9059-C07C6CD15F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3D018FB-103D-A741-8444-334F11A9CDB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4324796-2A90-1845-B8B0-B27A60AA9F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49CCB8-711A-4A4C-B185-63390C1C9F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3C354B-1A4C-A442-B5E0-FBBE5AA99D86}" type="datetimeFigureOut">
              <a:rPr lang="en-US" smtClean="0"/>
              <a:t>3/30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CADF81E-6588-BF41-A60F-646E5D9389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1CECF2B-BEA1-514F-A88A-96C7C36473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50106-2007-B641-8F44-4FFD711B4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2509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8328D55-479D-B240-B7F6-7FD0563C70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418B9A5-E9E2-184E-B2A2-A4E71D9B16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7DF71A-7F9A-8242-AD05-B24101D75B3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3C354B-1A4C-A442-B5E0-FBBE5AA99D86}" type="datetimeFigureOut">
              <a:rPr lang="en-US" smtClean="0"/>
              <a:t>3/30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F333D8-C897-7041-A83C-B73375B45A5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DC049F-C37C-6D43-8463-42FDA617456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050106-2007-B641-8F44-4FFD711B4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18544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9BF56CC3-D3CC-EC45-8126-958EA82301A7}"/>
              </a:ext>
            </a:extLst>
          </p:cNvPr>
          <p:cNvGrpSpPr/>
          <p:nvPr/>
        </p:nvGrpSpPr>
        <p:grpSpPr>
          <a:xfrm>
            <a:off x="2619911" y="0"/>
            <a:ext cx="7767262" cy="6673334"/>
            <a:chOff x="2619911" y="0"/>
            <a:chExt cx="7767262" cy="6673334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E2D41084-1E5E-5740-ABEA-B585FBFB6D88}"/>
                </a:ext>
              </a:extLst>
            </p:cNvPr>
            <p:cNvSpPr txBox="1"/>
            <p:nvPr/>
          </p:nvSpPr>
          <p:spPr>
            <a:xfrm>
              <a:off x="2619911" y="5842337"/>
              <a:ext cx="7767262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4. Example of Grid of True Underlying </a:t>
              </a:r>
              <a:r>
                <a:rPr lang="en-U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revalences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f Undiagnosed  HIV Infection.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values in the individual squares represent the starting value (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=0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of </a:t>
              </a:r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revalences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f undiagnosed HIV infection 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P</a:t>
              </a:r>
              <a:r>
                <a:rPr lang="en-US" sz="1200" i="1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t)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or each zone. Each iteration of a given data simulation setting starts with a new formulation of this grid and this is a representative sample of a grid </a:t>
              </a:r>
              <a:r>
                <a:rPr lang="en-US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>with high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rrelation and 20% hotspots on average.</a:t>
              </a:r>
              <a:endPara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60E3CEC9-B13B-A249-8567-E32AC239E73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7027"/>
            <a:stretch/>
          </p:blipFill>
          <p:spPr>
            <a:xfrm>
              <a:off x="3099490" y="0"/>
              <a:ext cx="6294476" cy="585216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8059219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79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nsalves, Gregg</dc:creator>
  <cp:lastModifiedBy>Gonsalves, Gregg</cp:lastModifiedBy>
  <cp:revision>5</cp:revision>
  <dcterms:created xsi:type="dcterms:W3CDTF">2018-03-29T12:13:05Z</dcterms:created>
  <dcterms:modified xsi:type="dcterms:W3CDTF">2018-03-30T10:41:41Z</dcterms:modified>
</cp:coreProperties>
</file>